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4" d="100"/>
          <a:sy n="54" d="100"/>
        </p:scale>
        <p:origin x="18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083AA-B9F7-4CCE-9D7C-E9B6BDD5E8CF}" type="datetimeFigureOut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DA7F2C-DC39-47C3-8E6F-7DB1C305CD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4476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0D1F7-5226-4E34-B35E-088B90C886B7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926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2594-9FB0-4B3E-A5C0-B2A0ADF7E280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317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BB984-E43F-4227-8149-CE3B06937F25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2662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EC5F-944A-4AC4-9B91-D339B695A44B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7058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8897C-DB9F-4B43-AFCB-100DE78F427A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380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BB97-2321-4395-9855-228F476036B7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977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8D6F8-ABE6-41DD-8CD0-BF9BF299C789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29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230B0-D54F-4721-A536-B6853B286B70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9159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01BCD-8397-4C34-AFB1-5F3D872296B1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0798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9D48F-15C1-4EFD-98C3-8017A7882303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6516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EE91E-FB58-4059-A60D-2764025FA130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511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57485-7C98-4FB0-8A39-D9107E590B25}" type="datetime1">
              <a:rPr lang="zh-CN" altLang="en-US" smtClean="0"/>
              <a:t>2025/6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97221-D313-4CEB-8FFA-B93682C4DF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566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7" Type="http://schemas.openxmlformats.org/officeDocument/2006/relationships/image" Target="../media/image24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g"/><Relationship Id="rId5" Type="http://schemas.openxmlformats.org/officeDocument/2006/relationships/image" Target="../media/image22.jpg"/><Relationship Id="rId4" Type="http://schemas.openxmlformats.org/officeDocument/2006/relationships/image" Target="../media/image2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7" Type="http://schemas.openxmlformats.org/officeDocument/2006/relationships/image" Target="../media/image36.jpg"/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jpg"/><Relationship Id="rId5" Type="http://schemas.openxmlformats.org/officeDocument/2006/relationships/image" Target="../media/image34.jpg"/><Relationship Id="rId4" Type="http://schemas.openxmlformats.org/officeDocument/2006/relationships/image" Target="../media/image3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B636EB3-C6A9-3EEE-3678-C83C1DE49A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6" y="1018045"/>
            <a:ext cx="3048000" cy="2286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883436" y="741046"/>
            <a:ext cx="1814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73EB870-A04C-9268-838E-AD58D3FABD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8" y="1018045"/>
            <a:ext cx="3048000" cy="2286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96028" y="752660"/>
            <a:ext cx="18998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52410539-E997-B8C1-12D8-C5DA7D5986C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6" y="3707901"/>
            <a:ext cx="3048000" cy="2286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925915" y="3430902"/>
            <a:ext cx="1729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3563C127-40DE-FF29-365A-ACCA0B0BE5A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8" y="3707901"/>
            <a:ext cx="3048000" cy="228600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138507" y="3430901"/>
            <a:ext cx="1814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7F9BBDEB-ABEA-008A-6C4B-D91311920F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6" y="6412045"/>
            <a:ext cx="3048000" cy="228600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803284" y="6135046"/>
            <a:ext cx="1975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A4762404-88B0-6895-C031-5FD3F8E8C92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8" y="6412045"/>
            <a:ext cx="3048000" cy="228600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058356" y="6135046"/>
            <a:ext cx="2060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442923"/>
            <a:ext cx="20233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4g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egative grou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A64EF60-F180-3205-EF2A-43D9977AAF3E}"/>
              </a:ext>
            </a:extLst>
          </p:cNvPr>
          <p:cNvSpPr txBox="1"/>
          <p:nvPr/>
        </p:nvSpPr>
        <p:spPr>
          <a:xfrm>
            <a:off x="266896" y="8729655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7314E1D-5BB5-7E21-4072-EED382290CBD}"/>
              </a:ext>
            </a:extLst>
          </p:cNvPr>
          <p:cNvSpPr txBox="1"/>
          <p:nvPr/>
        </p:nvSpPr>
        <p:spPr>
          <a:xfrm>
            <a:off x="109227" y="126149"/>
            <a:ext cx="6189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Dataset 10_The original data of immunohistochemistry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id="{B16BF1FE-0153-8358-048C-5D651C1ED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9181392"/>
            <a:ext cx="1543050" cy="527403"/>
          </a:xfrm>
        </p:spPr>
        <p:txBody>
          <a:bodyPr/>
          <a:lstStyle/>
          <a:p>
            <a:fld id="{5FD97221-D313-4CEB-8FFA-B93682C4DF00}" type="slidenum">
              <a:rPr lang="zh-CN" altLang="en-US" smtClean="0"/>
              <a:t>1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79996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917097" y="369563"/>
            <a:ext cx="1747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87211" y="387482"/>
            <a:ext cx="18325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1002056" y="3173722"/>
            <a:ext cx="1662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138507" y="3173722"/>
            <a:ext cx="1747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803284" y="5977883"/>
            <a:ext cx="1907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058356" y="5977883"/>
            <a:ext cx="1992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71440"/>
            <a:ext cx="1944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. 4g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sitive grou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D7D2F4A-434E-8452-34DA-6541D7F224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6" y="646562"/>
            <a:ext cx="3048000" cy="2286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0EE49D6-DA53-D6AE-04B6-E98905D6F1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8" y="646562"/>
            <a:ext cx="3048000" cy="2286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344E2FA-2101-B907-89A1-EF7023F896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3450722"/>
            <a:ext cx="3048000" cy="2286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292D366C-5199-BC38-8BB4-CB445F76A7A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3450721"/>
            <a:ext cx="3048000" cy="2286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B1B443A1-8192-0262-1632-0B929B3C21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254882"/>
            <a:ext cx="3048000" cy="2286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18BAE2D6-8B38-C995-B768-08D55BB83D6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6254880"/>
            <a:ext cx="3048000" cy="228600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9C3A3822-9272-4246-021E-7D2135FD3056}"/>
              </a:ext>
            </a:extLst>
          </p:cNvPr>
          <p:cNvSpPr txBox="1"/>
          <p:nvPr/>
        </p:nvSpPr>
        <p:spPr>
          <a:xfrm>
            <a:off x="266896" y="8715372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5E8AEA2B-4E2C-2CFF-A473-8EBFC12ED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0849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917097" y="369563"/>
            <a:ext cx="2037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0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02252" y="387482"/>
            <a:ext cx="2165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0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1450094" y="3173720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475137" y="3173720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1305823" y="5977880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330867" y="5971200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71440"/>
            <a:ext cx="39437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HC grade 0 for 66CT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C09EABF-9398-2057-39CA-E81104132C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64481"/>
            <a:ext cx="3048000" cy="2286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3AA9582-4DC8-673D-1797-F44D2AB841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664481"/>
            <a:ext cx="3048000" cy="2286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7E4ED5B-C099-8ADB-F4D9-0477F77132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3450721"/>
            <a:ext cx="3048000" cy="2286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C1CE20A-353D-DAFE-7C9B-99434ED8BD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3459680"/>
            <a:ext cx="3048000" cy="2286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93090CF-800A-9D12-4A48-CE9E315D9C6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254880"/>
            <a:ext cx="3048000" cy="2286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9AF6486C-8EAF-E177-1820-0033C2E525D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6254880"/>
            <a:ext cx="3048000" cy="228600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DC1A1BDA-D033-2F26-3ACA-E112263A1A81}"/>
              </a:ext>
            </a:extLst>
          </p:cNvPr>
          <p:cNvSpPr txBox="1"/>
          <p:nvPr/>
        </p:nvSpPr>
        <p:spPr>
          <a:xfrm>
            <a:off x="266896" y="8715372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64F68CB7-E50A-440D-703D-30C7AB40C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4851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917097" y="369563"/>
            <a:ext cx="2037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1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02252" y="387482"/>
            <a:ext cx="2122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1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1305023" y="3173721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475137" y="3173720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1088209" y="5977880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352507" y="5977880"/>
            <a:ext cx="1301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71440"/>
            <a:ext cx="39437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HC grade 1 for 66CT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7FA5C2D-DADB-57C2-B90F-877D036B13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64481"/>
            <a:ext cx="3048000" cy="2286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79A9FB8-A986-A247-30B6-2920FB57A8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664481"/>
            <a:ext cx="3048000" cy="2286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795C32E-FFC7-A868-90DD-A2F74C6F35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3450720"/>
            <a:ext cx="3048000" cy="2286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4C6235D-E34D-21CF-F768-B00AC42EBD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3459680"/>
            <a:ext cx="3048000" cy="2286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5B86B7E-5C21-65A1-4562-F335D3F1BF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254880"/>
            <a:ext cx="3048000" cy="2286000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6B5EB3AC-D24F-0FF4-51AF-65667F64D3C3}"/>
              </a:ext>
            </a:extLst>
          </p:cNvPr>
          <p:cNvSpPr txBox="1"/>
          <p:nvPr/>
        </p:nvSpPr>
        <p:spPr>
          <a:xfrm>
            <a:off x="266896" y="8715372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F98BA168-0E07-6291-9B23-FC0C0D524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4</a:t>
            </a:fld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EAD3944-B6E5-62B8-DB21-40B0B126D20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0988" y="6254880"/>
            <a:ext cx="30480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89081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917097" y="369563"/>
            <a:ext cx="2037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2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02252" y="387482"/>
            <a:ext cx="2122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2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1305023" y="3173721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475137" y="3173720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1088209" y="5977880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352507" y="5977880"/>
            <a:ext cx="1301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71440"/>
            <a:ext cx="39437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HC grade 2 for 66CT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23D3886-0510-ADD1-BC8C-CB2188F532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64481"/>
            <a:ext cx="3048000" cy="2286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67FCBA6-7D1E-D303-E412-203BF5F3FE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7" y="664481"/>
            <a:ext cx="3048000" cy="2286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7B46F03-00ED-DB1F-8430-D87ADE380B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3459680"/>
            <a:ext cx="3048000" cy="2286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E98A699-41D5-9FA0-6E11-73439E78FF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6" y="3459680"/>
            <a:ext cx="3048000" cy="2286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722F69E-037D-DBB3-8FBC-BBB35FA7E75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254879"/>
            <a:ext cx="3048000" cy="2286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17D519DF-FD04-BC1F-50D5-2E8B1B193C7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6" y="6254879"/>
            <a:ext cx="3048000" cy="228600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DD38E093-AE82-B4BF-9ED6-A99FFDC118D5}"/>
              </a:ext>
            </a:extLst>
          </p:cNvPr>
          <p:cNvSpPr txBox="1"/>
          <p:nvPr/>
        </p:nvSpPr>
        <p:spPr>
          <a:xfrm>
            <a:off x="266896" y="8715372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5EA73BD3-88E7-2560-FE00-AD45F3272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80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A91D3C8-482D-4A12-B040-59A16B8093B8}"/>
              </a:ext>
            </a:extLst>
          </p:cNvPr>
          <p:cNvSpPr txBox="1"/>
          <p:nvPr/>
        </p:nvSpPr>
        <p:spPr>
          <a:xfrm>
            <a:off x="917097" y="369563"/>
            <a:ext cx="2037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3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8F3D427-0BD8-F540-5C61-897716FCB211}"/>
              </a:ext>
            </a:extLst>
          </p:cNvPr>
          <p:cNvSpPr txBox="1"/>
          <p:nvPr/>
        </p:nvSpPr>
        <p:spPr>
          <a:xfrm>
            <a:off x="4002252" y="387482"/>
            <a:ext cx="2122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HC grade 3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CTG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B7BD0F0-52C1-6A22-E9B4-A002E86F81AF}"/>
              </a:ext>
            </a:extLst>
          </p:cNvPr>
          <p:cNvSpPr txBox="1"/>
          <p:nvPr/>
        </p:nvSpPr>
        <p:spPr>
          <a:xfrm>
            <a:off x="1305023" y="3173721"/>
            <a:ext cx="971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3AAB87-EB28-C7B1-D0FF-22043E500DA3}"/>
              </a:ext>
            </a:extLst>
          </p:cNvPr>
          <p:cNvSpPr txBox="1"/>
          <p:nvPr/>
        </p:nvSpPr>
        <p:spPr>
          <a:xfrm>
            <a:off x="4475137" y="3173720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-Myc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8890610-CE64-2F7C-6844-E5199F203D25}"/>
              </a:ext>
            </a:extLst>
          </p:cNvPr>
          <p:cNvSpPr txBox="1"/>
          <p:nvPr/>
        </p:nvSpPr>
        <p:spPr>
          <a:xfrm>
            <a:off x="1088209" y="5977880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4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70622D6-1D34-3B63-D5C5-1BD2C6AACCBA}"/>
              </a:ext>
            </a:extLst>
          </p:cNvPr>
          <p:cNvSpPr txBox="1"/>
          <p:nvPr/>
        </p:nvSpPr>
        <p:spPr>
          <a:xfrm>
            <a:off x="4352507" y="5977880"/>
            <a:ext cx="1301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yclin D1 (20 ×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C82C0F-EC0B-E818-91B8-6E0037C07648}"/>
              </a:ext>
            </a:extLst>
          </p:cNvPr>
          <p:cNvSpPr txBox="1"/>
          <p:nvPr/>
        </p:nvSpPr>
        <p:spPr>
          <a:xfrm>
            <a:off x="199820" y="71440"/>
            <a:ext cx="39437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HC grade 3 for 66CT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A3F995D-9008-A3C7-F2DD-24E27DA3F4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096" y="655521"/>
            <a:ext cx="3048000" cy="2286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9D9611C-933F-65CC-E38A-FF38F6DE3A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6" y="655520"/>
            <a:ext cx="3048000" cy="2286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A47D35F-73CA-E3F6-0BA4-3B6377C3D4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3459680"/>
            <a:ext cx="3048000" cy="2286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27F8A96-A313-97C0-5D7C-40472083C15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6" y="3459680"/>
            <a:ext cx="3048000" cy="2286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A639D69-1753-BBB2-F646-08E9412F3A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4" y="6254879"/>
            <a:ext cx="3048000" cy="2286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1048D47D-72ED-30CA-084B-6D372F427E4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9486" y="6263840"/>
            <a:ext cx="3048000" cy="228600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BFEF2B2C-9C10-0D98-5066-F65758CF7631}"/>
              </a:ext>
            </a:extLst>
          </p:cNvPr>
          <p:cNvSpPr txBox="1"/>
          <p:nvPr/>
        </p:nvSpPr>
        <p:spPr>
          <a:xfrm>
            <a:off x="266896" y="8715372"/>
            <a:ext cx="6260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munohistochemical staining for 66CTG, c-Myc, and Cyclin D1 was performed on paraffin-embedded tissue sections of clinical triple-negative breast cancer prepared by continuous slicing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3A6119FD-21F0-6063-90B7-B80916A94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97221-D313-4CEB-8FFA-B93682C4DF00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2456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4</TotalTime>
  <Words>429</Words>
  <Application>Microsoft Office PowerPoint</Application>
  <PresentationFormat>A4 纸张(210x297 毫米)</PresentationFormat>
  <Paragraphs>5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慧春 梁</dc:creator>
  <cp:lastModifiedBy>慧春 梁</cp:lastModifiedBy>
  <cp:revision>27</cp:revision>
  <dcterms:created xsi:type="dcterms:W3CDTF">2025-05-29T13:37:09Z</dcterms:created>
  <dcterms:modified xsi:type="dcterms:W3CDTF">2025-06-03T08:31:59Z</dcterms:modified>
</cp:coreProperties>
</file>